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48"/>
    <p:restoredTop sz="96327"/>
  </p:normalViewPr>
  <p:slideViewPr>
    <p:cSldViewPr snapToGrid="0" snapToObjects="1">
      <p:cViewPr>
        <p:scale>
          <a:sx n="116" d="100"/>
          <a:sy n="116" d="100"/>
        </p:scale>
        <p:origin x="20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476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952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8923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623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696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852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365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968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8902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605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7664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8D8BC-BA37-1844-9809-FD229E1D4DA0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4078A-16BC-3745-9C88-BC47E0204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1144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B1B45A5-BB71-8844-8534-D7C1578B93FA}"/>
              </a:ext>
            </a:extLst>
          </p:cNvPr>
          <p:cNvGrpSpPr/>
          <p:nvPr/>
        </p:nvGrpSpPr>
        <p:grpSpPr>
          <a:xfrm>
            <a:off x="787141" y="504268"/>
            <a:ext cx="8026919" cy="11733796"/>
            <a:chOff x="787141" y="504268"/>
            <a:chExt cx="8026919" cy="11733796"/>
          </a:xfrm>
        </p:grpSpPr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246A733C-A915-F044-A66F-C3BB05965CE5}"/>
                </a:ext>
              </a:extLst>
            </p:cNvPr>
            <p:cNvGrpSpPr/>
            <p:nvPr/>
          </p:nvGrpSpPr>
          <p:grpSpPr>
            <a:xfrm>
              <a:off x="787141" y="734720"/>
              <a:ext cx="4074225" cy="11496609"/>
              <a:chOff x="721329" y="631825"/>
              <a:chExt cx="4074225" cy="11496609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B4F2BEA-8541-EF4F-B915-11AFAA61D8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3909" b="55445"/>
              <a:stretch/>
            </p:blipFill>
            <p:spPr>
              <a:xfrm>
                <a:off x="721329" y="631825"/>
                <a:ext cx="4074225" cy="11496609"/>
              </a:xfrm>
              <a:prstGeom prst="rect">
                <a:avLst/>
              </a:prstGeom>
            </p:spPr>
          </p:pic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3B9BBE8E-254A-A849-AE3B-598B195FCCCB}"/>
                  </a:ext>
                </a:extLst>
              </p:cNvPr>
              <p:cNvGrpSpPr/>
              <p:nvPr/>
            </p:nvGrpSpPr>
            <p:grpSpPr>
              <a:xfrm>
                <a:off x="2743200" y="669925"/>
                <a:ext cx="1714500" cy="11401425"/>
                <a:chOff x="2743200" y="669925"/>
                <a:chExt cx="1714500" cy="11401425"/>
              </a:xfrm>
              <a:solidFill>
                <a:schemeClr val="bg1"/>
              </a:solidFill>
            </p:grpSpPr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A880C3EE-B62F-9142-905B-084A64CCADE1}"/>
                    </a:ext>
                  </a:extLst>
                </p:cNvPr>
                <p:cNvSpPr/>
                <p:nvPr/>
              </p:nvSpPr>
              <p:spPr>
                <a:xfrm>
                  <a:off x="3927475" y="4991101"/>
                  <a:ext cx="514350" cy="69850"/>
                </a:xfrm>
                <a:prstGeom prst="rect">
                  <a:avLst/>
                </a:prstGeom>
                <a:grpFill/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CD1F7318-8FC5-9640-A568-707A35EE1A11}"/>
                    </a:ext>
                  </a:extLst>
                </p:cNvPr>
                <p:cNvGrpSpPr/>
                <p:nvPr/>
              </p:nvGrpSpPr>
              <p:grpSpPr>
                <a:xfrm>
                  <a:off x="2743200" y="669925"/>
                  <a:ext cx="1714500" cy="11401425"/>
                  <a:chOff x="2743200" y="669925"/>
                  <a:chExt cx="1714500" cy="11401425"/>
                </a:xfrm>
                <a:grpFill/>
              </p:grpSpPr>
              <p:sp>
                <p:nvSpPr>
                  <p:cNvPr id="29" name="Rectangle 28">
                    <a:extLst>
                      <a:ext uri="{FF2B5EF4-FFF2-40B4-BE49-F238E27FC236}">
                        <a16:creationId xmlns:a16="http://schemas.microsoft.com/office/drawing/2014/main" id="{1E9299EB-CE72-8C43-8FB8-D1658DC6780E}"/>
                      </a:ext>
                    </a:extLst>
                  </p:cNvPr>
                  <p:cNvSpPr/>
                  <p:nvPr/>
                </p:nvSpPr>
                <p:spPr>
                  <a:xfrm>
                    <a:off x="2743200" y="11941175"/>
                    <a:ext cx="1714500" cy="130175"/>
                  </a:xfrm>
                  <a:prstGeom prst="rect">
                    <a:avLst/>
                  </a:prstGeom>
                  <a:grp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D1EE58FD-F7DC-3443-8687-2B163AEE8215}"/>
                      </a:ext>
                    </a:extLst>
                  </p:cNvPr>
                  <p:cNvGrpSpPr/>
                  <p:nvPr/>
                </p:nvGrpSpPr>
                <p:grpSpPr>
                  <a:xfrm>
                    <a:off x="3133725" y="669925"/>
                    <a:ext cx="1320799" cy="9201149"/>
                    <a:chOff x="3133725" y="669925"/>
                    <a:chExt cx="1320799" cy="9201149"/>
                  </a:xfrm>
                  <a:grpFill/>
                </p:grpSpPr>
                <p:grpSp>
                  <p:nvGrpSpPr>
                    <p:cNvPr id="42" name="Group 41">
                      <a:extLst>
                        <a:ext uri="{FF2B5EF4-FFF2-40B4-BE49-F238E27FC236}">
                          <a16:creationId xmlns:a16="http://schemas.microsoft.com/office/drawing/2014/main" id="{3D7E1D58-9492-9F4A-B13E-103C8ED3CEB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33725" y="669925"/>
                      <a:ext cx="1317625" cy="6257924"/>
                      <a:chOff x="3133725" y="669925"/>
                      <a:chExt cx="1317625" cy="6257924"/>
                    </a:xfrm>
                    <a:grpFill/>
                  </p:grpSpPr>
                  <p:grpSp>
                    <p:nvGrpSpPr>
                      <p:cNvPr id="38" name="Group 37">
                        <a:extLst>
                          <a:ext uri="{FF2B5EF4-FFF2-40B4-BE49-F238E27FC236}">
                            <a16:creationId xmlns:a16="http://schemas.microsoft.com/office/drawing/2014/main" id="{6E1737FF-1DAF-8743-ADE9-2A59F6971CF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33725" y="669925"/>
                        <a:ext cx="1311274" cy="4749799"/>
                        <a:chOff x="3133725" y="669925"/>
                        <a:chExt cx="1311274" cy="4749799"/>
                      </a:xfrm>
                      <a:grpFill/>
                    </p:grpSpPr>
                    <p:grpSp>
                      <p:nvGrpSpPr>
                        <p:cNvPr id="34" name="Group 33">
                          <a:extLst>
                            <a:ext uri="{FF2B5EF4-FFF2-40B4-BE49-F238E27FC236}">
                              <a16:creationId xmlns:a16="http://schemas.microsoft.com/office/drawing/2014/main" id="{08E8D520-9347-9D49-A582-F4BD231EB78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133725" y="669925"/>
                          <a:ext cx="1308100" cy="4333875"/>
                          <a:chOff x="3133725" y="669925"/>
                          <a:chExt cx="1308100" cy="4333875"/>
                        </a:xfrm>
                        <a:grpFill/>
                      </p:grpSpPr>
                      <p:grpSp>
                        <p:nvGrpSpPr>
                          <p:cNvPr id="28" name="Group 27">
                            <a:extLst>
                              <a:ext uri="{FF2B5EF4-FFF2-40B4-BE49-F238E27FC236}">
                                <a16:creationId xmlns:a16="http://schemas.microsoft.com/office/drawing/2014/main" id="{1D6CF7CE-9F1E-4145-9C96-89170DD9AF12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133725" y="669925"/>
                            <a:ext cx="1298575" cy="3133726"/>
                            <a:chOff x="3133725" y="669925"/>
                            <a:chExt cx="1298575" cy="3133726"/>
                          </a:xfrm>
                          <a:grpFill/>
                        </p:grpSpPr>
                        <p:grpSp>
                          <p:nvGrpSpPr>
                            <p:cNvPr id="21" name="Group 20">
                              <a:extLst>
                                <a:ext uri="{FF2B5EF4-FFF2-40B4-BE49-F238E27FC236}">
                                  <a16:creationId xmlns:a16="http://schemas.microsoft.com/office/drawing/2014/main" id="{40195F53-F404-7945-AD59-ADF99EC8BDD8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133725" y="669925"/>
                              <a:ext cx="1295400" cy="2066924"/>
                              <a:chOff x="3133725" y="669925"/>
                              <a:chExt cx="1295400" cy="2066924"/>
                            </a:xfrm>
                            <a:grpFill/>
                          </p:grpSpPr>
                          <p:sp>
                            <p:nvSpPr>
                              <p:cNvPr id="12" name="Rectangle 11">
                                <a:extLst>
                                  <a:ext uri="{FF2B5EF4-FFF2-40B4-BE49-F238E27FC236}">
                                    <a16:creationId xmlns:a16="http://schemas.microsoft.com/office/drawing/2014/main" id="{F816B632-ABE5-7E41-89CC-CE96E75D08DE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241675" y="669925"/>
                                <a:ext cx="1177925" cy="161925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3" name="Rectangle 12">
                                <a:extLst>
                                  <a:ext uri="{FF2B5EF4-FFF2-40B4-BE49-F238E27FC236}">
                                    <a16:creationId xmlns:a16="http://schemas.microsoft.com/office/drawing/2014/main" id="{AE3A455A-1665-0D44-8968-3A1A627D1176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292475" y="781050"/>
                                <a:ext cx="1130300" cy="450850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4" name="Rectangle 13">
                                <a:extLst>
                                  <a:ext uri="{FF2B5EF4-FFF2-40B4-BE49-F238E27FC236}">
                                    <a16:creationId xmlns:a16="http://schemas.microsoft.com/office/drawing/2014/main" id="{48593651-D7D8-DA46-A31B-489287D38CF5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429000" y="1190625"/>
                                <a:ext cx="993775" cy="469900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5" name="Rectangle 14">
                                <a:extLst>
                                  <a:ext uri="{FF2B5EF4-FFF2-40B4-BE49-F238E27FC236}">
                                    <a16:creationId xmlns:a16="http://schemas.microsoft.com/office/drawing/2014/main" id="{CB9E6870-8B12-ED4F-8D30-3CB819FEC0C8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302000" y="1654176"/>
                                <a:ext cx="1123950" cy="107950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6" name="Rectangle 15">
                                <a:extLst>
                                  <a:ext uri="{FF2B5EF4-FFF2-40B4-BE49-F238E27FC236}">
                                    <a16:creationId xmlns:a16="http://schemas.microsoft.com/office/drawing/2014/main" id="{1B56E1B7-B035-6B4E-BCA9-4EA1C3152ADF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133725" y="1711325"/>
                                <a:ext cx="1292225" cy="79375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7" name="Rectangle 16">
                                <a:extLst>
                                  <a:ext uri="{FF2B5EF4-FFF2-40B4-BE49-F238E27FC236}">
                                    <a16:creationId xmlns:a16="http://schemas.microsoft.com/office/drawing/2014/main" id="{32A43019-614D-734D-8CC1-1B912B306D30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171825" y="1755776"/>
                                <a:ext cx="1257300" cy="136524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8" name="Rectangle 17">
                                <a:extLst>
                                  <a:ext uri="{FF2B5EF4-FFF2-40B4-BE49-F238E27FC236}">
                                    <a16:creationId xmlns:a16="http://schemas.microsoft.com/office/drawing/2014/main" id="{58735669-78A6-7448-8F07-A1AB5847C154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384549" y="1851026"/>
                                <a:ext cx="1044575" cy="107950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19" name="Rectangle 18">
                                <a:extLst>
                                  <a:ext uri="{FF2B5EF4-FFF2-40B4-BE49-F238E27FC236}">
                                    <a16:creationId xmlns:a16="http://schemas.microsoft.com/office/drawing/2014/main" id="{50CD079B-E9A1-B149-ADBA-CA02EC3173AB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660775" y="1908175"/>
                                <a:ext cx="768349" cy="228599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  <p:sp>
                            <p:nvSpPr>
                              <p:cNvPr id="20" name="Rectangle 19">
                                <a:extLst>
                                  <a:ext uri="{FF2B5EF4-FFF2-40B4-BE49-F238E27FC236}">
                                    <a16:creationId xmlns:a16="http://schemas.microsoft.com/office/drawing/2014/main" id="{5AD61A6E-A4C6-C840-9E4A-F82DD5E3DB68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3733800" y="2127250"/>
                                <a:ext cx="695324" cy="609599"/>
                              </a:xfrm>
                              <a:prstGeom prst="rect">
                                <a:avLst/>
                              </a:prstGeom>
                              <a:grpFill/>
                              <a:ln w="3175">
                                <a:solidFill>
                                  <a:schemeClr val="bg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</p:grpSp>
                        <p:sp>
                          <p:nvSpPr>
                            <p:cNvPr id="22" name="Rectangle 21">
                              <a:extLst>
                                <a:ext uri="{FF2B5EF4-FFF2-40B4-BE49-F238E27FC236}">
                                  <a16:creationId xmlns:a16="http://schemas.microsoft.com/office/drawing/2014/main" id="{89B31B6C-5531-CD44-8E6A-7802E0F43981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571875" y="2714626"/>
                              <a:ext cx="857250" cy="374650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sp>
                          <p:nvSpPr>
                            <p:cNvPr id="23" name="Rectangle 22">
                              <a:extLst>
                                <a:ext uri="{FF2B5EF4-FFF2-40B4-BE49-F238E27FC236}">
                                  <a16:creationId xmlns:a16="http://schemas.microsoft.com/office/drawing/2014/main" id="{11326E62-C56B-6840-8B37-2F22D9A99B04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717925" y="3032126"/>
                              <a:ext cx="714375" cy="120650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sp>
                          <p:nvSpPr>
                            <p:cNvPr id="24" name="Rectangle 23">
                              <a:extLst>
                                <a:ext uri="{FF2B5EF4-FFF2-40B4-BE49-F238E27FC236}">
                                  <a16:creationId xmlns:a16="http://schemas.microsoft.com/office/drawing/2014/main" id="{E9371785-6BE5-8641-BCBD-8DA3EC60CCA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816350" y="3117851"/>
                              <a:ext cx="612775" cy="292100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sp>
                          <p:nvSpPr>
                            <p:cNvPr id="25" name="Rectangle 24">
                              <a:extLst>
                                <a:ext uri="{FF2B5EF4-FFF2-40B4-BE49-F238E27FC236}">
                                  <a16:creationId xmlns:a16="http://schemas.microsoft.com/office/drawing/2014/main" id="{C985C4A8-81D4-9648-A0AD-883E56B186A1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746500" y="3375026"/>
                              <a:ext cx="682625" cy="139700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sp>
                          <p:nvSpPr>
                            <p:cNvPr id="26" name="Rectangle 25">
                              <a:extLst>
                                <a:ext uri="{FF2B5EF4-FFF2-40B4-BE49-F238E27FC236}">
                                  <a16:creationId xmlns:a16="http://schemas.microsoft.com/office/drawing/2014/main" id="{5F1BB097-B60C-F640-9BEF-13E2FA5F4500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883025" y="3502025"/>
                              <a:ext cx="546100" cy="73025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sp>
                          <p:nvSpPr>
                            <p:cNvPr id="27" name="Rectangle 26">
                              <a:extLst>
                                <a:ext uri="{FF2B5EF4-FFF2-40B4-BE49-F238E27FC236}">
                                  <a16:creationId xmlns:a16="http://schemas.microsoft.com/office/drawing/2014/main" id="{5B9DB3F7-9D5F-174B-9CD8-BBC86BBC9F27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911600" y="3556001"/>
                              <a:ext cx="520700" cy="247650"/>
                            </a:xfrm>
                            <a:prstGeom prst="rect">
                              <a:avLst/>
                            </a:prstGeom>
                            <a:grpFill/>
                            <a:ln w="3175">
                              <a:solidFill>
                                <a:schemeClr val="bg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</p:grpSp>
                      <p:sp>
                        <p:nvSpPr>
                          <p:cNvPr id="30" name="Rectangle 29">
                            <a:extLst>
                              <a:ext uri="{FF2B5EF4-FFF2-40B4-BE49-F238E27FC236}">
                                <a16:creationId xmlns:a16="http://schemas.microsoft.com/office/drawing/2014/main" id="{AB524823-6E58-3E48-A51C-CED5C9070B4C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997325" y="3784600"/>
                            <a:ext cx="438150" cy="438150"/>
                          </a:xfrm>
                          <a:prstGeom prst="rect">
                            <a:avLst/>
                          </a:prstGeom>
                          <a:grpFill/>
                          <a:ln w="3175"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  <p:sp>
                        <p:nvSpPr>
                          <p:cNvPr id="31" name="Rectangle 30">
                            <a:extLst>
                              <a:ext uri="{FF2B5EF4-FFF2-40B4-BE49-F238E27FC236}">
                                <a16:creationId xmlns:a16="http://schemas.microsoft.com/office/drawing/2014/main" id="{793415AD-C31A-A041-9F34-34574A0B172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962400" y="4200525"/>
                            <a:ext cx="473075" cy="203200"/>
                          </a:xfrm>
                          <a:prstGeom prst="rect">
                            <a:avLst/>
                          </a:prstGeom>
                          <a:grpFill/>
                          <a:ln w="3175"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  <p:sp>
                        <p:nvSpPr>
                          <p:cNvPr id="32" name="Rectangle 31">
                            <a:extLst>
                              <a:ext uri="{FF2B5EF4-FFF2-40B4-BE49-F238E27FC236}">
                                <a16:creationId xmlns:a16="http://schemas.microsoft.com/office/drawing/2014/main" id="{596468CA-8EBE-AB44-AB96-F9F0BB99786B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022725" y="4378324"/>
                            <a:ext cx="415925" cy="447675"/>
                          </a:xfrm>
                          <a:prstGeom prst="rect">
                            <a:avLst/>
                          </a:prstGeom>
                          <a:grpFill/>
                          <a:ln w="3175"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  <p:sp>
                        <p:nvSpPr>
                          <p:cNvPr id="33" name="Rectangle 32">
                            <a:extLst>
                              <a:ext uri="{FF2B5EF4-FFF2-40B4-BE49-F238E27FC236}">
                                <a16:creationId xmlns:a16="http://schemas.microsoft.com/office/drawing/2014/main" id="{B094A95D-C4F5-0C4B-BF9C-83E6A3E14AC1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095750" y="4806949"/>
                            <a:ext cx="346075" cy="196851"/>
                          </a:xfrm>
                          <a:prstGeom prst="rect">
                            <a:avLst/>
                          </a:prstGeom>
                          <a:grpFill/>
                          <a:ln w="3175">
                            <a:solidFill>
                              <a:schemeClr val="bg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</p:grpSp>
                    <p:sp>
                      <p:nvSpPr>
                        <p:cNvPr id="36" name="Rectangle 35">
                          <a:extLst>
                            <a:ext uri="{FF2B5EF4-FFF2-40B4-BE49-F238E27FC236}">
                              <a16:creationId xmlns:a16="http://schemas.microsoft.com/office/drawing/2014/main" id="{D53B5B14-8A9D-F848-BD55-61B939CE32E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003675" y="5054601"/>
                          <a:ext cx="438150" cy="73024"/>
                        </a:xfrm>
                        <a:prstGeom prst="rect">
                          <a:avLst/>
                        </a:prstGeom>
                        <a:grpFill/>
                        <a:ln w="3175">
                          <a:solidFill>
                            <a:schemeClr val="bg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  <p:sp>
                      <p:nvSpPr>
                        <p:cNvPr id="37" name="Rectangle 36">
                          <a:extLst>
                            <a:ext uri="{FF2B5EF4-FFF2-40B4-BE49-F238E27FC236}">
                              <a16:creationId xmlns:a16="http://schemas.microsoft.com/office/drawing/2014/main" id="{473AB167-EBC1-DE40-96C7-1DA891F8F14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092574" y="5114925"/>
                          <a:ext cx="352425" cy="304799"/>
                        </a:xfrm>
                        <a:prstGeom prst="rect">
                          <a:avLst/>
                        </a:prstGeom>
                        <a:grpFill/>
                        <a:ln w="3175">
                          <a:solidFill>
                            <a:schemeClr val="bg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</p:grpSp>
                  <p:sp>
                    <p:nvSpPr>
                      <p:cNvPr id="39" name="Rectangle 38">
                        <a:extLst>
                          <a:ext uri="{FF2B5EF4-FFF2-40B4-BE49-F238E27FC236}">
                            <a16:creationId xmlns:a16="http://schemas.microsoft.com/office/drawing/2014/main" id="{B1A3AD0D-182E-C449-B122-6475D47596D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029075" y="5407025"/>
                        <a:ext cx="419100" cy="139699"/>
                      </a:xfrm>
                      <a:prstGeom prst="rect">
                        <a:avLst/>
                      </a:prstGeom>
                      <a:grpFill/>
                      <a:ln w="3175">
                        <a:solidFill>
                          <a:schemeClr val="bg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/>
                      </a:p>
                    </p:txBody>
                  </p:sp>
                  <p:sp>
                    <p:nvSpPr>
                      <p:cNvPr id="40" name="Rectangle 39">
                        <a:extLst>
                          <a:ext uri="{FF2B5EF4-FFF2-40B4-BE49-F238E27FC236}">
                            <a16:creationId xmlns:a16="http://schemas.microsoft.com/office/drawing/2014/main" id="{681BA863-D50F-A24F-884A-BC51360FE0E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146550" y="5540376"/>
                        <a:ext cx="304800" cy="130174"/>
                      </a:xfrm>
                      <a:prstGeom prst="rect">
                        <a:avLst/>
                      </a:prstGeom>
                      <a:grpFill/>
                      <a:ln w="3175">
                        <a:solidFill>
                          <a:schemeClr val="bg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/>
                      </a:p>
                    </p:txBody>
                  </p:sp>
                  <p:sp>
                    <p:nvSpPr>
                      <p:cNvPr id="41" name="Rectangle 40">
                        <a:extLst>
                          <a:ext uri="{FF2B5EF4-FFF2-40B4-BE49-F238E27FC236}">
                            <a16:creationId xmlns:a16="http://schemas.microsoft.com/office/drawing/2014/main" id="{C78C1C87-1AA9-B34C-92B2-A5E28C37857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308474" y="5638800"/>
                        <a:ext cx="142875" cy="1289049"/>
                      </a:xfrm>
                      <a:prstGeom prst="rect">
                        <a:avLst/>
                      </a:prstGeom>
                      <a:grpFill/>
                      <a:ln w="3175">
                        <a:solidFill>
                          <a:schemeClr val="bg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/>
                      </a:p>
                    </p:txBody>
                  </p:sp>
                </p:grpSp>
                <p:sp>
                  <p:nvSpPr>
                    <p:cNvPr id="43" name="Rectangle 42">
                      <a:extLst>
                        <a:ext uri="{FF2B5EF4-FFF2-40B4-BE49-F238E27FC236}">
                          <a16:creationId xmlns:a16="http://schemas.microsoft.com/office/drawing/2014/main" id="{E27F617C-D8D9-B542-A363-16B8A7FA0FA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08805" y="6921499"/>
                      <a:ext cx="45719" cy="2949575"/>
                    </a:xfrm>
                    <a:prstGeom prst="rect">
                      <a:avLst/>
                    </a:prstGeom>
                    <a:grpFill/>
                    <a:ln w="3175"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45" name="Rectangle 44">
                    <a:extLst>
                      <a:ext uri="{FF2B5EF4-FFF2-40B4-BE49-F238E27FC236}">
                        <a16:creationId xmlns:a16="http://schemas.microsoft.com/office/drawing/2014/main" id="{BA45B571-EABD-D542-BE62-794B748C0B92}"/>
                      </a:ext>
                    </a:extLst>
                  </p:cNvPr>
                  <p:cNvSpPr/>
                  <p:nvPr/>
                </p:nvSpPr>
                <p:spPr>
                  <a:xfrm>
                    <a:off x="4356099" y="9858375"/>
                    <a:ext cx="98425" cy="1006475"/>
                  </a:xfrm>
                  <a:prstGeom prst="rect">
                    <a:avLst/>
                  </a:prstGeom>
                  <a:grp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46" name="Rectangle 45">
                    <a:extLst>
                      <a:ext uri="{FF2B5EF4-FFF2-40B4-BE49-F238E27FC236}">
                        <a16:creationId xmlns:a16="http://schemas.microsoft.com/office/drawing/2014/main" id="{E3079B7B-9EED-D644-AF26-56F34A0EAD2D}"/>
                      </a:ext>
                    </a:extLst>
                  </p:cNvPr>
                  <p:cNvSpPr/>
                  <p:nvPr/>
                </p:nvSpPr>
                <p:spPr>
                  <a:xfrm>
                    <a:off x="4314825" y="10852150"/>
                    <a:ext cx="139700" cy="377825"/>
                  </a:xfrm>
                  <a:prstGeom prst="rect">
                    <a:avLst/>
                  </a:prstGeom>
                  <a:grp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47" name="Rectangle 46">
                    <a:extLst>
                      <a:ext uri="{FF2B5EF4-FFF2-40B4-BE49-F238E27FC236}">
                        <a16:creationId xmlns:a16="http://schemas.microsoft.com/office/drawing/2014/main" id="{12DD484A-364B-2C40-A7D5-9B6A891644CB}"/>
                      </a:ext>
                    </a:extLst>
                  </p:cNvPr>
                  <p:cNvSpPr/>
                  <p:nvPr/>
                </p:nvSpPr>
                <p:spPr>
                  <a:xfrm>
                    <a:off x="4203699" y="11210925"/>
                    <a:ext cx="250825" cy="676275"/>
                  </a:xfrm>
                  <a:prstGeom prst="rect">
                    <a:avLst/>
                  </a:prstGeom>
                  <a:grp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48" name="Rectangle 47">
                    <a:extLst>
                      <a:ext uri="{FF2B5EF4-FFF2-40B4-BE49-F238E27FC236}">
                        <a16:creationId xmlns:a16="http://schemas.microsoft.com/office/drawing/2014/main" id="{0110B4A2-1FFF-6640-B592-4113CEDC2F25}"/>
                      </a:ext>
                    </a:extLst>
                  </p:cNvPr>
                  <p:cNvSpPr/>
                  <p:nvPr/>
                </p:nvSpPr>
                <p:spPr>
                  <a:xfrm>
                    <a:off x="4102100" y="11868151"/>
                    <a:ext cx="355600" cy="114300"/>
                  </a:xfrm>
                  <a:prstGeom prst="rect">
                    <a:avLst/>
                  </a:prstGeom>
                  <a:grpFill/>
                  <a:ln w="317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</p:grp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ED36C74-7E1D-CE4A-846D-82BE716638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944" r="62268" b="55406"/>
            <a:stretch/>
          </p:blipFill>
          <p:spPr>
            <a:xfrm>
              <a:off x="4488734" y="740250"/>
              <a:ext cx="1537274" cy="11497814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166079F-1C18-E748-9619-B691993439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8335" t="3944" r="20208" b="55406"/>
            <a:stretch/>
          </p:blipFill>
          <p:spPr>
            <a:xfrm>
              <a:off x="6012739" y="740250"/>
              <a:ext cx="1689100" cy="11497814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0B20F95-0CA4-9A43-9322-A6389710ED74}"/>
                </a:ext>
              </a:extLst>
            </p:cNvPr>
            <p:cNvSpPr txBox="1"/>
            <p:nvPr/>
          </p:nvSpPr>
          <p:spPr>
            <a:xfrm>
              <a:off x="7699652" y="504268"/>
              <a:ext cx="1114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Clades &amp; Subclades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FC604F2-2461-9C47-AD9F-53F7C85914F5}"/>
                </a:ext>
              </a:extLst>
            </p:cNvPr>
            <p:cNvSpPr txBox="1"/>
            <p:nvPr/>
          </p:nvSpPr>
          <p:spPr>
            <a:xfrm>
              <a:off x="4818852" y="504268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>
                  <a:latin typeface="Arial" panose="020B0604020202020204" pitchFamily="34" charset="0"/>
                  <a:cs typeface="Arial" panose="020B0604020202020204" pitchFamily="34" charset="0"/>
                </a:rPr>
                <a:t>Uniform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21CDE9E-9F4F-2B4D-831D-B891129097B8}"/>
                </a:ext>
              </a:extLst>
            </p:cNvPr>
            <p:cNvSpPr txBox="1"/>
            <p:nvPr/>
          </p:nvSpPr>
          <p:spPr>
            <a:xfrm>
              <a:off x="1673199" y="50426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Real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9384201-BFDF-7044-8FA8-713EDB0946BA}"/>
                </a:ext>
              </a:extLst>
            </p:cNvPr>
            <p:cNvSpPr txBox="1"/>
            <p:nvPr/>
          </p:nvSpPr>
          <p:spPr>
            <a:xfrm>
              <a:off x="5946344" y="504268"/>
              <a:ext cx="14654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pecies [protein] &amp; distance</a:t>
              </a:r>
            </a:p>
          </p:txBody>
        </p: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4B96334E-0A67-984A-9208-C9579CE5C236}"/>
                </a:ext>
              </a:extLst>
            </p:cNvPr>
            <p:cNvGrpSpPr/>
            <p:nvPr/>
          </p:nvGrpSpPr>
          <p:grpSpPr>
            <a:xfrm>
              <a:off x="7799511" y="791870"/>
              <a:ext cx="60926" cy="11367172"/>
              <a:chOff x="6266849" y="688975"/>
              <a:chExt cx="1772250" cy="11367172"/>
            </a:xfrm>
          </p:grpSpPr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FFE7D649-46DB-C547-8490-66F5F89F293E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688975"/>
                <a:ext cx="1772249" cy="11938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99EC7109-DA2C-0C4D-8BD4-B01B9D96DB22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1882291"/>
                <a:ext cx="1772249" cy="841859"/>
              </a:xfrm>
              <a:prstGeom prst="rect">
                <a:avLst/>
              </a:prstGeom>
              <a:solidFill>
                <a:schemeClr val="accent6"/>
              </a:solidFill>
              <a:ln w="3175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7834D11A-0259-6F4F-9DE2-0635B017DFA9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2724151"/>
                <a:ext cx="1772249" cy="653812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68052B0E-C04B-934B-9998-80F0B9256222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3378766"/>
                <a:ext cx="1772249" cy="602684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3175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45205BF7-2A0B-FE4D-AAB5-D0754E084B5D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3981281"/>
                <a:ext cx="1772249" cy="101299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8" name="Rectangle 77">
                <a:extLst>
                  <a:ext uri="{FF2B5EF4-FFF2-40B4-BE49-F238E27FC236}">
                    <a16:creationId xmlns:a16="http://schemas.microsoft.com/office/drawing/2014/main" id="{F114FCC8-572F-534E-AAFB-123A0CC38DA7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49" y="4995285"/>
                <a:ext cx="1772249" cy="6945890"/>
              </a:xfrm>
              <a:prstGeom prst="rect">
                <a:avLst/>
              </a:prstGeom>
              <a:solidFill>
                <a:schemeClr val="accent5"/>
              </a:solidFill>
              <a:ln w="31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79" name="Rectangle 78">
                <a:extLst>
                  <a:ext uri="{FF2B5EF4-FFF2-40B4-BE49-F238E27FC236}">
                    <a16:creationId xmlns:a16="http://schemas.microsoft.com/office/drawing/2014/main" id="{E730E6D2-BB6C-1042-A431-7181B7137B95}"/>
                  </a:ext>
                </a:extLst>
              </p:cNvPr>
              <p:cNvSpPr>
                <a:spLocks/>
              </p:cNvSpPr>
              <p:nvPr/>
            </p:nvSpPr>
            <p:spPr>
              <a:xfrm flipH="1">
                <a:off x="6266850" y="11941643"/>
                <a:ext cx="1772249" cy="11450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E55592A0-99A4-F447-841E-114ED35E20B8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3484270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122A02CC-CC00-D744-8C37-373FC9A7F46B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2827045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4B848191-81A7-C44B-800C-55272EF56FFC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1988845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E00546D2-41E1-E54A-9419-E269ECB89124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791870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39AADB75-A956-CA4D-B1C9-D1C75F3E1FEB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4087520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41BBE9ED-1C46-B044-956A-8A85AD5F9690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5100345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57CC86FA-6464-7044-AD6E-12EC4CE1C2EC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12047245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B72D8107-C6F3-E44C-B8BF-3F72A27B8FA1}"/>
                </a:ext>
              </a:extLst>
            </p:cNvPr>
            <p:cNvCxnSpPr>
              <a:cxnSpLocks/>
            </p:cNvCxnSpPr>
            <p:nvPr/>
          </p:nvCxnSpPr>
          <p:spPr>
            <a:xfrm>
              <a:off x="6006237" y="12161545"/>
              <a:ext cx="176212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C0F142F-89FB-E34E-9F8A-50F5F40F9D2B}"/>
                </a:ext>
              </a:extLst>
            </p:cNvPr>
            <p:cNvSpPr txBox="1"/>
            <p:nvPr/>
          </p:nvSpPr>
          <p:spPr>
            <a:xfrm>
              <a:off x="7826652" y="1306487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1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5A3C9C6-2AC7-FD42-9F50-174052DC8D18}"/>
                </a:ext>
              </a:extLst>
            </p:cNvPr>
            <p:cNvSpPr txBox="1"/>
            <p:nvPr/>
          </p:nvSpPr>
          <p:spPr>
            <a:xfrm>
              <a:off x="7826652" y="2319312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2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2AB4E18-FC22-154A-8F34-236E60BE18C8}"/>
                </a:ext>
              </a:extLst>
            </p:cNvPr>
            <p:cNvSpPr txBox="1"/>
            <p:nvPr/>
          </p:nvSpPr>
          <p:spPr>
            <a:xfrm>
              <a:off x="7826652" y="3065437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3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D9AF780-B3F5-2D4B-978E-C0659CD29D7F}"/>
                </a:ext>
              </a:extLst>
            </p:cNvPr>
            <p:cNvSpPr txBox="1"/>
            <p:nvPr/>
          </p:nvSpPr>
          <p:spPr>
            <a:xfrm>
              <a:off x="7826652" y="3703612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4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55BC964-78F8-AD4F-A069-179617A06342}"/>
                </a:ext>
              </a:extLst>
            </p:cNvPr>
            <p:cNvSpPr txBox="1"/>
            <p:nvPr/>
          </p:nvSpPr>
          <p:spPr>
            <a:xfrm>
              <a:off x="7826652" y="4510062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5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07237BB2-1C86-8649-AE47-F1F1C11E85DB}"/>
                </a:ext>
              </a:extLst>
            </p:cNvPr>
            <p:cNvSpPr txBox="1"/>
            <p:nvPr/>
          </p:nvSpPr>
          <p:spPr>
            <a:xfrm>
              <a:off x="7826652" y="8483196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6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BBA2273C-2966-B644-BCB4-CC0E5F3FD8FE}"/>
                </a:ext>
              </a:extLst>
            </p:cNvPr>
            <p:cNvSpPr txBox="1"/>
            <p:nvPr/>
          </p:nvSpPr>
          <p:spPr>
            <a:xfrm>
              <a:off x="7826652" y="12022112"/>
              <a:ext cx="4042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ade 7</a:t>
              </a: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7B30B96A-71B4-6843-BADA-E0069F4D9BAB}"/>
                </a:ext>
              </a:extLst>
            </p:cNvPr>
            <p:cNvSpPr>
              <a:spLocks/>
            </p:cNvSpPr>
            <p:nvPr/>
          </p:nvSpPr>
          <p:spPr>
            <a:xfrm flipH="1">
              <a:off x="8245698" y="5163457"/>
              <a:ext cx="71648" cy="355988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EE64323A-0D0D-3A4F-9C14-F0124645D26F}"/>
                </a:ext>
              </a:extLst>
            </p:cNvPr>
            <p:cNvSpPr>
              <a:spLocks/>
            </p:cNvSpPr>
            <p:nvPr/>
          </p:nvSpPr>
          <p:spPr>
            <a:xfrm flipH="1">
              <a:off x="8245698" y="5519782"/>
              <a:ext cx="72000" cy="126664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3175"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A869266B-AD52-7944-B8A6-F281F098A823}"/>
                </a:ext>
              </a:extLst>
            </p:cNvPr>
            <p:cNvSpPr>
              <a:spLocks/>
            </p:cNvSpPr>
            <p:nvPr/>
          </p:nvSpPr>
          <p:spPr>
            <a:xfrm flipH="1">
              <a:off x="8245698" y="5646782"/>
              <a:ext cx="72000" cy="11713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E0E8B0E2-EA89-1B47-90C3-D26FA9425BBF}"/>
                </a:ext>
              </a:extLst>
            </p:cNvPr>
            <p:cNvSpPr>
              <a:spLocks/>
            </p:cNvSpPr>
            <p:nvPr/>
          </p:nvSpPr>
          <p:spPr>
            <a:xfrm flipH="1">
              <a:off x="8245698" y="11447170"/>
              <a:ext cx="72000" cy="533400"/>
            </a:xfrm>
            <a:prstGeom prst="rect">
              <a:avLst/>
            </a:prstGeom>
            <a:solidFill>
              <a:schemeClr val="accent2"/>
            </a:solidFill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89452067-A3A7-8546-8B77-147EB1E9D020}"/>
                </a:ext>
              </a:extLst>
            </p:cNvPr>
            <p:cNvSpPr>
              <a:spLocks/>
            </p:cNvSpPr>
            <p:nvPr/>
          </p:nvSpPr>
          <p:spPr>
            <a:xfrm flipH="1">
              <a:off x="8245698" y="5763920"/>
              <a:ext cx="72000" cy="561975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3175">
              <a:solidFill>
                <a:schemeClr val="accent5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2E8DE69F-E0A7-E945-B8EF-45C8AD35C96D}"/>
                </a:ext>
              </a:extLst>
            </p:cNvPr>
            <p:cNvSpPr txBox="1"/>
            <p:nvPr/>
          </p:nvSpPr>
          <p:spPr>
            <a:xfrm>
              <a:off x="8282937" y="5260814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ubclade 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16DAB952-A2D4-444C-BD97-477256DB89A5}"/>
                </a:ext>
              </a:extLst>
            </p:cNvPr>
            <p:cNvSpPr txBox="1"/>
            <p:nvPr/>
          </p:nvSpPr>
          <p:spPr>
            <a:xfrm>
              <a:off x="8282937" y="5498564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ubclade 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6E3828D3-460F-A147-BCCA-47EA402EB5C3}"/>
                </a:ext>
              </a:extLst>
            </p:cNvPr>
            <p:cNvSpPr txBox="1"/>
            <p:nvPr/>
          </p:nvSpPr>
          <p:spPr>
            <a:xfrm>
              <a:off x="8282937" y="5624399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ubclade 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63F219B-9EBC-2C4C-A756-97137AF40CF4}"/>
                </a:ext>
              </a:extLst>
            </p:cNvPr>
            <p:cNvSpPr txBox="1"/>
            <p:nvPr/>
          </p:nvSpPr>
          <p:spPr>
            <a:xfrm>
              <a:off x="8282937" y="8483196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ubclade 4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0041B40C-5235-C647-8147-57CB380873F2}"/>
                </a:ext>
              </a:extLst>
            </p:cNvPr>
            <p:cNvSpPr txBox="1"/>
            <p:nvPr/>
          </p:nvSpPr>
          <p:spPr>
            <a:xfrm>
              <a:off x="8282937" y="11633714"/>
              <a:ext cx="5036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ubclade 5</a:t>
              </a:r>
            </a:p>
          </p:txBody>
        </p: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8315A463-B313-E24B-B1AB-351350AEFC60}"/>
                </a:ext>
              </a:extLst>
            </p:cNvPr>
            <p:cNvCxnSpPr>
              <a:cxnSpLocks/>
            </p:cNvCxnSpPr>
            <p:nvPr/>
          </p:nvCxnSpPr>
          <p:spPr>
            <a:xfrm>
              <a:off x="7892187" y="5101315"/>
              <a:ext cx="33337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B944596B-23BE-864B-B945-3951DB181A4F}"/>
                </a:ext>
              </a:extLst>
            </p:cNvPr>
            <p:cNvCxnSpPr>
              <a:cxnSpLocks/>
            </p:cNvCxnSpPr>
            <p:nvPr/>
          </p:nvCxnSpPr>
          <p:spPr>
            <a:xfrm>
              <a:off x="7892187" y="12047245"/>
              <a:ext cx="333375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6" name="Group 215">
              <a:extLst>
                <a:ext uri="{FF2B5EF4-FFF2-40B4-BE49-F238E27FC236}">
                  <a16:creationId xmlns:a16="http://schemas.microsoft.com/office/drawing/2014/main" id="{77B15B96-84A6-954C-A07B-0F35AE9C7DEE}"/>
                </a:ext>
              </a:extLst>
            </p:cNvPr>
            <p:cNvGrpSpPr/>
            <p:nvPr/>
          </p:nvGrpSpPr>
          <p:grpSpPr>
            <a:xfrm>
              <a:off x="1940880" y="8882013"/>
              <a:ext cx="2011224" cy="3027852"/>
              <a:chOff x="4773144" y="1792447"/>
              <a:chExt cx="2011224" cy="3027852"/>
            </a:xfrm>
          </p:grpSpPr>
          <p:sp>
            <p:nvSpPr>
              <p:cNvPr id="217" name="Freeform 216">
                <a:extLst>
                  <a:ext uri="{FF2B5EF4-FFF2-40B4-BE49-F238E27FC236}">
                    <a16:creationId xmlns:a16="http://schemas.microsoft.com/office/drawing/2014/main" id="{0A5C6176-24CF-234A-8C69-6FCBEC4ADCE3}"/>
                  </a:ext>
                </a:extLst>
              </p:cNvPr>
              <p:cNvSpPr/>
              <p:nvPr/>
            </p:nvSpPr>
            <p:spPr>
              <a:xfrm>
                <a:off x="5172805" y="2156281"/>
                <a:ext cx="162435" cy="117488"/>
              </a:xfrm>
              <a:custGeom>
                <a:avLst/>
                <a:gdLst>
                  <a:gd name="connsiteX0" fmla="*/ 221343 w 221343"/>
                  <a:gd name="connsiteY0" fmla="*/ 0 h 301171"/>
                  <a:gd name="connsiteX1" fmla="*/ 221343 w 221343"/>
                  <a:gd name="connsiteY1" fmla="*/ 301171 h 301171"/>
                  <a:gd name="connsiteX2" fmla="*/ 0 w 221343"/>
                  <a:gd name="connsiteY2" fmla="*/ 76200 h 301171"/>
                  <a:gd name="connsiteX3" fmla="*/ 221343 w 221343"/>
                  <a:gd name="connsiteY3" fmla="*/ 0 h 3011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21343" h="301171">
                    <a:moveTo>
                      <a:pt x="221343" y="0"/>
                    </a:moveTo>
                    <a:lnTo>
                      <a:pt x="221343" y="301171"/>
                    </a:lnTo>
                    <a:lnTo>
                      <a:pt x="0" y="76200"/>
                    </a:lnTo>
                    <a:lnTo>
                      <a:pt x="221343" y="0"/>
                    </a:lnTo>
                    <a:close/>
                  </a:path>
                </a:pathLst>
              </a:custGeom>
              <a:solidFill>
                <a:schemeClr val="accent4"/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8" name="Freeform 217">
                <a:extLst>
                  <a:ext uri="{FF2B5EF4-FFF2-40B4-BE49-F238E27FC236}">
                    <a16:creationId xmlns:a16="http://schemas.microsoft.com/office/drawing/2014/main" id="{DDC5D691-B389-5D40-8A14-42264FDFAF92}"/>
                  </a:ext>
                </a:extLst>
              </p:cNvPr>
              <p:cNvSpPr/>
              <p:nvPr/>
            </p:nvSpPr>
            <p:spPr>
              <a:xfrm>
                <a:off x="5190420" y="2290589"/>
                <a:ext cx="69235" cy="25479"/>
              </a:xfrm>
              <a:custGeom>
                <a:avLst/>
                <a:gdLst>
                  <a:gd name="connsiteX0" fmla="*/ 94343 w 94343"/>
                  <a:gd name="connsiteY0" fmla="*/ 0 h 65314"/>
                  <a:gd name="connsiteX1" fmla="*/ 94343 w 94343"/>
                  <a:gd name="connsiteY1" fmla="*/ 65314 h 65314"/>
                  <a:gd name="connsiteX2" fmla="*/ 0 w 94343"/>
                  <a:gd name="connsiteY2" fmla="*/ 36286 h 65314"/>
                  <a:gd name="connsiteX3" fmla="*/ 94343 w 94343"/>
                  <a:gd name="connsiteY3" fmla="*/ 0 h 653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4343" h="65314">
                    <a:moveTo>
                      <a:pt x="94343" y="0"/>
                    </a:moveTo>
                    <a:lnTo>
                      <a:pt x="94343" y="65314"/>
                    </a:lnTo>
                    <a:lnTo>
                      <a:pt x="0" y="36286"/>
                    </a:lnTo>
                    <a:lnTo>
                      <a:pt x="94343" y="0"/>
                    </a:lnTo>
                    <a:close/>
                  </a:path>
                </a:pathLst>
              </a:custGeom>
              <a:solidFill>
                <a:schemeClr val="bg1">
                  <a:lumMod val="95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9" name="Freeform 218">
                <a:extLst>
                  <a:ext uri="{FF2B5EF4-FFF2-40B4-BE49-F238E27FC236}">
                    <a16:creationId xmlns:a16="http://schemas.microsoft.com/office/drawing/2014/main" id="{CDCF383B-C560-A747-B8BF-E70BAC3A846C}"/>
                  </a:ext>
                </a:extLst>
              </p:cNvPr>
              <p:cNvSpPr/>
              <p:nvPr/>
            </p:nvSpPr>
            <p:spPr>
              <a:xfrm>
                <a:off x="5280958" y="2338540"/>
                <a:ext cx="69235" cy="25479"/>
              </a:xfrm>
              <a:custGeom>
                <a:avLst/>
                <a:gdLst>
                  <a:gd name="connsiteX0" fmla="*/ 94343 w 94343"/>
                  <a:gd name="connsiteY0" fmla="*/ 0 h 65314"/>
                  <a:gd name="connsiteX1" fmla="*/ 94343 w 94343"/>
                  <a:gd name="connsiteY1" fmla="*/ 65314 h 65314"/>
                  <a:gd name="connsiteX2" fmla="*/ 0 w 94343"/>
                  <a:gd name="connsiteY2" fmla="*/ 36286 h 65314"/>
                  <a:gd name="connsiteX3" fmla="*/ 94343 w 94343"/>
                  <a:gd name="connsiteY3" fmla="*/ 0 h 653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4343" h="65314">
                    <a:moveTo>
                      <a:pt x="94343" y="0"/>
                    </a:moveTo>
                    <a:lnTo>
                      <a:pt x="94343" y="65314"/>
                    </a:lnTo>
                    <a:lnTo>
                      <a:pt x="0" y="36286"/>
                    </a:lnTo>
                    <a:lnTo>
                      <a:pt x="94343" y="0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0" name="Freeform 219">
                <a:extLst>
                  <a:ext uri="{FF2B5EF4-FFF2-40B4-BE49-F238E27FC236}">
                    <a16:creationId xmlns:a16="http://schemas.microsoft.com/office/drawing/2014/main" id="{09787227-763F-504D-985D-51E873E6A248}"/>
                  </a:ext>
                </a:extLst>
              </p:cNvPr>
              <p:cNvSpPr/>
              <p:nvPr/>
            </p:nvSpPr>
            <p:spPr>
              <a:xfrm>
                <a:off x="5356542" y="4603724"/>
                <a:ext cx="58583" cy="189680"/>
              </a:xfrm>
              <a:custGeom>
                <a:avLst/>
                <a:gdLst>
                  <a:gd name="connsiteX0" fmla="*/ 79829 w 79829"/>
                  <a:gd name="connsiteY0" fmla="*/ 0 h 486228"/>
                  <a:gd name="connsiteX1" fmla="*/ 79829 w 79829"/>
                  <a:gd name="connsiteY1" fmla="*/ 486228 h 486228"/>
                  <a:gd name="connsiteX2" fmla="*/ 0 w 79829"/>
                  <a:gd name="connsiteY2" fmla="*/ 333828 h 486228"/>
                  <a:gd name="connsiteX3" fmla="*/ 79829 w 79829"/>
                  <a:gd name="connsiteY3" fmla="*/ 0 h 4862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9829" h="486228">
                    <a:moveTo>
                      <a:pt x="79829" y="0"/>
                    </a:moveTo>
                    <a:lnTo>
                      <a:pt x="79829" y="486228"/>
                    </a:lnTo>
                    <a:lnTo>
                      <a:pt x="0" y="333828"/>
                    </a:lnTo>
                    <a:lnTo>
                      <a:pt x="79829" y="0"/>
                    </a:lnTo>
                    <a:close/>
                  </a:path>
                </a:pathLst>
              </a:custGeom>
              <a:solidFill>
                <a:schemeClr val="accent2"/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21" name="Straight Connector 220">
                <a:extLst>
                  <a:ext uri="{FF2B5EF4-FFF2-40B4-BE49-F238E27FC236}">
                    <a16:creationId xmlns:a16="http://schemas.microsoft.com/office/drawing/2014/main" id="{21A38849-E378-1347-AFE3-AC6EE5617B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81982" y="4387149"/>
                <a:ext cx="0" cy="431735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Straight Connector 221">
                <a:extLst>
                  <a:ext uri="{FF2B5EF4-FFF2-40B4-BE49-F238E27FC236}">
                    <a16:creationId xmlns:a16="http://schemas.microsoft.com/office/drawing/2014/main" id="{A2333A69-2654-0A45-BC3C-007BDDE4EE4F}"/>
                  </a:ext>
                </a:extLst>
              </p:cNvPr>
              <p:cNvCxnSpPr/>
              <p:nvPr/>
            </p:nvCxnSpPr>
            <p:spPr>
              <a:xfrm>
                <a:off x="5278475" y="4820299"/>
                <a:ext cx="3728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>
                <a:extLst>
                  <a:ext uri="{FF2B5EF4-FFF2-40B4-BE49-F238E27FC236}">
                    <a16:creationId xmlns:a16="http://schemas.microsoft.com/office/drawing/2014/main" id="{3718FF9E-8FE5-1749-8B8C-DF9C8E629201}"/>
                  </a:ext>
                </a:extLst>
              </p:cNvPr>
              <p:cNvCxnSpPr/>
              <p:nvPr/>
            </p:nvCxnSpPr>
            <p:spPr>
              <a:xfrm>
                <a:off x="5278475" y="4387148"/>
                <a:ext cx="42606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Straight Connector 223">
                <a:extLst>
                  <a:ext uri="{FF2B5EF4-FFF2-40B4-BE49-F238E27FC236}">
                    <a16:creationId xmlns:a16="http://schemas.microsoft.com/office/drawing/2014/main" id="{453FD34D-D0EA-374C-B7B2-B087B8CB55C9}"/>
                  </a:ext>
                </a:extLst>
              </p:cNvPr>
              <p:cNvCxnSpPr/>
              <p:nvPr/>
            </p:nvCxnSpPr>
            <p:spPr>
              <a:xfrm>
                <a:off x="5196770" y="4600893"/>
                <a:ext cx="85212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Straight Connector 224">
                <a:extLst>
                  <a:ext uri="{FF2B5EF4-FFF2-40B4-BE49-F238E27FC236}">
                    <a16:creationId xmlns:a16="http://schemas.microsoft.com/office/drawing/2014/main" id="{DB0EDCA1-7CB6-F04B-832E-450365B4449B}"/>
                  </a:ext>
                </a:extLst>
              </p:cNvPr>
              <p:cNvCxnSpPr/>
              <p:nvPr/>
            </p:nvCxnSpPr>
            <p:spPr>
              <a:xfrm>
                <a:off x="5350705" y="4583906"/>
                <a:ext cx="21303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Straight Connector 225">
                <a:extLst>
                  <a:ext uri="{FF2B5EF4-FFF2-40B4-BE49-F238E27FC236}">
                    <a16:creationId xmlns:a16="http://schemas.microsoft.com/office/drawing/2014/main" id="{6A4EDDE0-BFCF-2742-97D8-F69ED9C59ECC}"/>
                  </a:ext>
                </a:extLst>
              </p:cNvPr>
              <p:cNvCxnSpPr>
                <a:endCxn id="220" idx="2"/>
              </p:cNvCxnSpPr>
              <p:nvPr/>
            </p:nvCxnSpPr>
            <p:spPr>
              <a:xfrm>
                <a:off x="5353880" y="4583906"/>
                <a:ext cx="2662" cy="150045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>
                <a:extLst>
                  <a:ext uri="{FF2B5EF4-FFF2-40B4-BE49-F238E27FC236}">
                    <a16:creationId xmlns:a16="http://schemas.microsoft.com/office/drawing/2014/main" id="{625737C6-EB83-144F-BD9D-3F366C2F6CDA}"/>
                  </a:ext>
                </a:extLst>
              </p:cNvPr>
              <p:cNvCxnSpPr/>
              <p:nvPr/>
            </p:nvCxnSpPr>
            <p:spPr>
              <a:xfrm>
                <a:off x="5317931" y="4659273"/>
                <a:ext cx="3495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Straight Connector 227">
                <a:extLst>
                  <a:ext uri="{FF2B5EF4-FFF2-40B4-BE49-F238E27FC236}">
                    <a16:creationId xmlns:a16="http://schemas.microsoft.com/office/drawing/2014/main" id="{D3AECC59-A8B1-4548-8254-41F37093EDD1}"/>
                  </a:ext>
                </a:extLst>
              </p:cNvPr>
              <p:cNvCxnSpPr/>
              <p:nvPr/>
            </p:nvCxnSpPr>
            <p:spPr>
              <a:xfrm>
                <a:off x="5320261" y="4117314"/>
                <a:ext cx="0" cy="54250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9" name="Freeform 228">
                <a:extLst>
                  <a:ext uri="{FF2B5EF4-FFF2-40B4-BE49-F238E27FC236}">
                    <a16:creationId xmlns:a16="http://schemas.microsoft.com/office/drawing/2014/main" id="{4FE89D0C-534A-1943-A21F-D4F7A499DC94}"/>
                  </a:ext>
                </a:extLst>
              </p:cNvPr>
              <p:cNvSpPr/>
              <p:nvPr/>
            </p:nvSpPr>
            <p:spPr>
              <a:xfrm>
                <a:off x="5354089" y="2387011"/>
                <a:ext cx="212770" cy="2175075"/>
              </a:xfrm>
              <a:custGeom>
                <a:avLst/>
                <a:gdLst>
                  <a:gd name="connsiteX0" fmla="*/ 289932 w 289932"/>
                  <a:gd name="connsiteY0" fmla="*/ 0 h 5575610"/>
                  <a:gd name="connsiteX1" fmla="*/ 289932 w 289932"/>
                  <a:gd name="connsiteY1" fmla="*/ 5575610 h 5575610"/>
                  <a:gd name="connsiteX2" fmla="*/ 0 w 289932"/>
                  <a:gd name="connsiteY2" fmla="*/ 4438185 h 5575610"/>
                  <a:gd name="connsiteX3" fmla="*/ 289932 w 289932"/>
                  <a:gd name="connsiteY3" fmla="*/ 0 h 55756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89932" h="5575610">
                    <a:moveTo>
                      <a:pt x="289932" y="0"/>
                    </a:moveTo>
                    <a:lnTo>
                      <a:pt x="289932" y="5575610"/>
                    </a:lnTo>
                    <a:lnTo>
                      <a:pt x="0" y="4438185"/>
                    </a:lnTo>
                    <a:lnTo>
                      <a:pt x="289932" y="0"/>
                    </a:lnTo>
                    <a:close/>
                  </a:path>
                </a:pathLst>
              </a:custGeom>
              <a:solidFill>
                <a:schemeClr val="accent5">
                  <a:lumMod val="40000"/>
                  <a:lumOff val="60000"/>
                </a:schemeClr>
              </a:solidFill>
              <a:ln w="317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30" name="Straight Connector 229">
                <a:extLst>
                  <a:ext uri="{FF2B5EF4-FFF2-40B4-BE49-F238E27FC236}">
                    <a16:creationId xmlns:a16="http://schemas.microsoft.com/office/drawing/2014/main" id="{CADFAAF6-4BB1-E042-8E61-03E8A2379B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17086" y="4116075"/>
                <a:ext cx="40178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>
                <a:extLst>
                  <a:ext uri="{FF2B5EF4-FFF2-40B4-BE49-F238E27FC236}">
                    <a16:creationId xmlns:a16="http://schemas.microsoft.com/office/drawing/2014/main" id="{4AC2EDA1-12FB-084F-BE66-E9A58D0D479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99100" y="2354808"/>
                <a:ext cx="0" cy="2245554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>
                <a:extLst>
                  <a:ext uri="{FF2B5EF4-FFF2-40B4-BE49-F238E27FC236}">
                    <a16:creationId xmlns:a16="http://schemas.microsoft.com/office/drawing/2014/main" id="{796382B4-10F0-EA46-B324-07ED72466BF8}"/>
                  </a:ext>
                </a:extLst>
              </p:cNvPr>
              <p:cNvCxnSpPr/>
              <p:nvPr/>
            </p:nvCxnSpPr>
            <p:spPr>
              <a:xfrm>
                <a:off x="5196770" y="2354808"/>
                <a:ext cx="8621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Straight Connector 232">
                <a:extLst>
                  <a:ext uri="{FF2B5EF4-FFF2-40B4-BE49-F238E27FC236}">
                    <a16:creationId xmlns:a16="http://schemas.microsoft.com/office/drawing/2014/main" id="{4C45F388-3F5D-A045-9CEE-510AB9AF502F}"/>
                  </a:ext>
                </a:extLst>
              </p:cNvPr>
              <p:cNvCxnSpPr/>
              <p:nvPr/>
            </p:nvCxnSpPr>
            <p:spPr>
              <a:xfrm>
                <a:off x="5103570" y="3476966"/>
                <a:ext cx="9553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>
                <a:extLst>
                  <a:ext uri="{FF2B5EF4-FFF2-40B4-BE49-F238E27FC236}">
                    <a16:creationId xmlns:a16="http://schemas.microsoft.com/office/drawing/2014/main" id="{3427B007-48F2-8D48-B6B5-AF8ADD09C2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05900" y="2307742"/>
                <a:ext cx="0" cy="1170463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>
                <a:extLst>
                  <a:ext uri="{FF2B5EF4-FFF2-40B4-BE49-F238E27FC236}">
                    <a16:creationId xmlns:a16="http://schemas.microsoft.com/office/drawing/2014/main" id="{337A8536-12B1-FD47-8ED7-3B0C55827E6A}"/>
                  </a:ext>
                </a:extLst>
              </p:cNvPr>
              <p:cNvCxnSpPr/>
              <p:nvPr/>
            </p:nvCxnSpPr>
            <p:spPr>
              <a:xfrm>
                <a:off x="5102725" y="2306503"/>
                <a:ext cx="8854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>
                <a:extLst>
                  <a:ext uri="{FF2B5EF4-FFF2-40B4-BE49-F238E27FC236}">
                    <a16:creationId xmlns:a16="http://schemas.microsoft.com/office/drawing/2014/main" id="{6D3E8FEB-4786-CB44-92C3-7F3C879419CC}"/>
                  </a:ext>
                </a:extLst>
              </p:cNvPr>
              <p:cNvCxnSpPr/>
              <p:nvPr/>
            </p:nvCxnSpPr>
            <p:spPr>
              <a:xfrm flipH="1">
                <a:off x="5008040" y="2892354"/>
                <a:ext cx="9553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Straight Connector 236">
                <a:extLst>
                  <a:ext uri="{FF2B5EF4-FFF2-40B4-BE49-F238E27FC236}">
                    <a16:creationId xmlns:a16="http://schemas.microsoft.com/office/drawing/2014/main" id="{624CD706-FD35-4F42-B363-8F48C539826C}"/>
                  </a:ext>
                </a:extLst>
              </p:cNvPr>
              <p:cNvCxnSpPr/>
              <p:nvPr/>
            </p:nvCxnSpPr>
            <p:spPr>
              <a:xfrm flipV="1">
                <a:off x="5008040" y="2160350"/>
                <a:ext cx="0" cy="733242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>
                <a:extLst>
                  <a:ext uri="{FF2B5EF4-FFF2-40B4-BE49-F238E27FC236}">
                    <a16:creationId xmlns:a16="http://schemas.microsoft.com/office/drawing/2014/main" id="{8AA8A05C-9995-9F46-B1E7-7020460B05A0}"/>
                  </a:ext>
                </a:extLst>
              </p:cNvPr>
              <p:cNvCxnSpPr/>
              <p:nvPr/>
            </p:nvCxnSpPr>
            <p:spPr>
              <a:xfrm>
                <a:off x="5005710" y="2160350"/>
                <a:ext cx="10019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3BD62B49-B573-844A-8D9E-9A691B593813}"/>
                  </a:ext>
                </a:extLst>
              </p:cNvPr>
              <p:cNvCxnSpPr/>
              <p:nvPr/>
            </p:nvCxnSpPr>
            <p:spPr>
              <a:xfrm>
                <a:off x="5106745" y="2131863"/>
                <a:ext cx="0" cy="55736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>
                <a:extLst>
                  <a:ext uri="{FF2B5EF4-FFF2-40B4-BE49-F238E27FC236}">
                    <a16:creationId xmlns:a16="http://schemas.microsoft.com/office/drawing/2014/main" id="{2D0D5A32-112B-E14B-A1C0-EF11634188EF}"/>
                  </a:ext>
                </a:extLst>
              </p:cNvPr>
              <p:cNvCxnSpPr/>
              <p:nvPr/>
            </p:nvCxnSpPr>
            <p:spPr>
              <a:xfrm>
                <a:off x="5103570" y="2131863"/>
                <a:ext cx="6757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>
                <a:extLst>
                  <a:ext uri="{FF2B5EF4-FFF2-40B4-BE49-F238E27FC236}">
                    <a16:creationId xmlns:a16="http://schemas.microsoft.com/office/drawing/2014/main" id="{64AA6B71-44CC-7D4B-8C4E-D8B567B59899}"/>
                  </a:ext>
                </a:extLst>
              </p:cNvPr>
              <p:cNvCxnSpPr>
                <a:cxnSpLocks/>
                <a:endCxn id="217" idx="2"/>
              </p:cNvCxnSpPr>
              <p:nvPr/>
            </p:nvCxnSpPr>
            <p:spPr>
              <a:xfrm flipV="1">
                <a:off x="5105900" y="2186007"/>
                <a:ext cx="66905" cy="354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Straight Connector 241">
                <a:extLst>
                  <a:ext uri="{FF2B5EF4-FFF2-40B4-BE49-F238E27FC236}">
                    <a16:creationId xmlns:a16="http://schemas.microsoft.com/office/drawing/2014/main" id="{73896229-6DC5-3744-9ECD-3E7439269647}"/>
                  </a:ext>
                </a:extLst>
              </p:cNvPr>
              <p:cNvCxnSpPr/>
              <p:nvPr/>
            </p:nvCxnSpPr>
            <p:spPr>
              <a:xfrm>
                <a:off x="4889209" y="2524494"/>
                <a:ext cx="116501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49075F66-950B-D445-9FFA-C81CDFC80B56}"/>
                  </a:ext>
                </a:extLst>
              </p:cNvPr>
              <p:cNvSpPr txBox="1"/>
              <p:nvPr/>
            </p:nvSpPr>
            <p:spPr>
              <a:xfrm>
                <a:off x="5305598" y="2133365"/>
                <a:ext cx="85792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dirty="0">
                    <a:solidFill>
                      <a:schemeClr val="accent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bclade 1  </a:t>
                </a:r>
                <a:r>
                  <a:rPr lang="en-GB" sz="500" i="1" dirty="0">
                    <a:solidFill>
                      <a:schemeClr val="accent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. </a:t>
                </a:r>
                <a:r>
                  <a:rPr lang="en-GB" sz="500" i="1" dirty="0" err="1">
                    <a:solidFill>
                      <a:schemeClr val="accent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yringae</a:t>
                </a:r>
                <a:endParaRPr lang="en-GB" sz="500" i="1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9C4E247E-3477-E34C-B2EC-E430FE04393B}"/>
                  </a:ext>
                </a:extLst>
              </p:cNvPr>
              <p:cNvSpPr txBox="1"/>
              <p:nvPr/>
            </p:nvSpPr>
            <p:spPr>
              <a:xfrm>
                <a:off x="5318298" y="2238140"/>
                <a:ext cx="64953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ubclades 2 &amp; 3</a:t>
                </a:r>
              </a:p>
            </p:txBody>
          </p:sp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690DE86A-6DAA-8849-BAF3-290A2258E924}"/>
                  </a:ext>
                </a:extLst>
              </p:cNvPr>
              <p:cNvSpPr txBox="1"/>
              <p:nvPr/>
            </p:nvSpPr>
            <p:spPr>
              <a:xfrm>
                <a:off x="5540548" y="3393840"/>
                <a:ext cx="50366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ubclade 4</a:t>
                </a: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771E0904-D850-0947-BC39-C30944B5176A}"/>
                  </a:ext>
                </a:extLst>
              </p:cNvPr>
              <p:cNvSpPr txBox="1"/>
              <p:nvPr/>
            </p:nvSpPr>
            <p:spPr>
              <a:xfrm>
                <a:off x="5384973" y="4616215"/>
                <a:ext cx="93166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bclade 5  </a:t>
                </a:r>
                <a:r>
                  <a:rPr lang="en-GB" sz="500" i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. aeruginosa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902BABDC-8C85-5C43-9747-DDEFDAE84C16}"/>
                  </a:ext>
                </a:extLst>
              </p:cNvPr>
              <p:cNvSpPr txBox="1"/>
              <p:nvPr/>
            </p:nvSpPr>
            <p:spPr>
              <a:xfrm>
                <a:off x="4773144" y="1792447"/>
                <a:ext cx="2011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B) Clade 6 Orphan proteins</a:t>
                </a:r>
              </a:p>
            </p:txBody>
          </p:sp>
        </p:grp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id="{BA383896-7FE4-E448-AE3C-1112D12CAA2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5073" y="5355775"/>
              <a:ext cx="36000" cy="36000"/>
            </a:xfrm>
            <a:prstGeom prst="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D3DBA006-AC42-9042-8FF5-3452876A7F3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133594" y="5359404"/>
              <a:ext cx="36000" cy="36000"/>
            </a:xfrm>
            <a:prstGeom prst="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D4C2C7E9-EBD2-B146-9F09-CBA15A8CB4F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5076" y="7271672"/>
              <a:ext cx="36000" cy="36000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D4F59A70-DE72-E448-845E-AAEBC807054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413003" y="7271672"/>
              <a:ext cx="36000" cy="36000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7D9B6661-1D23-B246-A7E4-AE956324680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5068" y="11698529"/>
              <a:ext cx="36000" cy="3600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4" name="Rectangle 263">
              <a:extLst>
                <a:ext uri="{FF2B5EF4-FFF2-40B4-BE49-F238E27FC236}">
                  <a16:creationId xmlns:a16="http://schemas.microsoft.com/office/drawing/2014/main" id="{A1A72619-1BC7-6447-84AB-5BDFBBF4E1D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238820" y="11698529"/>
              <a:ext cx="36000" cy="3600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6" name="Rectangle 265">
              <a:extLst>
                <a:ext uri="{FF2B5EF4-FFF2-40B4-BE49-F238E27FC236}">
                  <a16:creationId xmlns:a16="http://schemas.microsoft.com/office/drawing/2014/main" id="{BE0CF8EE-4DA5-D54D-A388-22211E46BC2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5070" y="6375408"/>
              <a:ext cx="36000" cy="36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2E4A8A1E-BED1-784B-9E22-A4114EF87F3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347681" y="6375408"/>
              <a:ext cx="36000" cy="36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4" name="Oval 273">
              <a:extLst>
                <a:ext uri="{FF2B5EF4-FFF2-40B4-BE49-F238E27FC236}">
                  <a16:creationId xmlns:a16="http://schemas.microsoft.com/office/drawing/2014/main" id="{FF105C18-AE98-5D44-BE76-ED5A3AFB505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84390" y="2002692"/>
              <a:ext cx="36000" cy="3600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5" name="Oval 274">
              <a:extLst>
                <a:ext uri="{FF2B5EF4-FFF2-40B4-BE49-F238E27FC236}">
                  <a16:creationId xmlns:a16="http://schemas.microsoft.com/office/drawing/2014/main" id="{5A771235-D4F0-1840-A1F2-44329441CB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381856" y="2009042"/>
              <a:ext cx="36000" cy="3600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1" name="Oval 280">
              <a:extLst>
                <a:ext uri="{FF2B5EF4-FFF2-40B4-BE49-F238E27FC236}">
                  <a16:creationId xmlns:a16="http://schemas.microsoft.com/office/drawing/2014/main" id="{8F3FC823-8A2B-1543-8371-03B0E9A8BB1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81704" y="1764079"/>
              <a:ext cx="36000" cy="36000"/>
            </a:xfrm>
            <a:prstGeom prst="ellips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2" name="Oval 281">
              <a:extLst>
                <a:ext uri="{FF2B5EF4-FFF2-40B4-BE49-F238E27FC236}">
                  <a16:creationId xmlns:a16="http://schemas.microsoft.com/office/drawing/2014/main" id="{87779D0E-292A-D841-8FDC-A5CA3368414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296620" y="1767254"/>
              <a:ext cx="36000" cy="36000"/>
            </a:xfrm>
            <a:prstGeom prst="ellipse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0" name="Oval 169">
              <a:extLst>
                <a:ext uri="{FF2B5EF4-FFF2-40B4-BE49-F238E27FC236}">
                  <a16:creationId xmlns:a16="http://schemas.microsoft.com/office/drawing/2014/main" id="{C1641470-5F80-1E43-B35B-8E033B29235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784115" y="2605942"/>
              <a:ext cx="36000" cy="3600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1" name="Oval 170">
              <a:extLst>
                <a:ext uri="{FF2B5EF4-FFF2-40B4-BE49-F238E27FC236}">
                  <a16:creationId xmlns:a16="http://schemas.microsoft.com/office/drawing/2014/main" id="{26F2E4E6-9951-5B4B-8A17-08FF0BF99C8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87565" y="2602767"/>
              <a:ext cx="36000" cy="36000"/>
            </a:xfrm>
            <a:prstGeom prst="ellips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925014D5-94A0-DD4E-92BC-3090B2D7D1E8}"/>
                </a:ext>
              </a:extLst>
            </p:cNvPr>
            <p:cNvGrpSpPr/>
            <p:nvPr/>
          </p:nvGrpSpPr>
          <p:grpSpPr>
            <a:xfrm>
              <a:off x="1927176" y="5469288"/>
              <a:ext cx="1401866" cy="3123304"/>
              <a:chOff x="3308944" y="1792447"/>
              <a:chExt cx="1401866" cy="3123304"/>
            </a:xfrm>
          </p:grpSpPr>
          <p:grpSp>
            <p:nvGrpSpPr>
              <p:cNvPr id="175" name="Group 174">
                <a:extLst>
                  <a:ext uri="{FF2B5EF4-FFF2-40B4-BE49-F238E27FC236}">
                    <a16:creationId xmlns:a16="http://schemas.microsoft.com/office/drawing/2014/main" id="{CDB93F49-C183-DC4A-B741-96E0ADEA28EE}"/>
                  </a:ext>
                </a:extLst>
              </p:cNvPr>
              <p:cNvGrpSpPr/>
              <p:nvPr/>
            </p:nvGrpSpPr>
            <p:grpSpPr>
              <a:xfrm>
                <a:off x="3427449" y="2132656"/>
                <a:ext cx="1283361" cy="2783095"/>
                <a:chOff x="3427449" y="2132656"/>
                <a:chExt cx="1283361" cy="2783095"/>
              </a:xfrm>
            </p:grpSpPr>
            <p:cxnSp>
              <p:nvCxnSpPr>
                <p:cNvPr id="177" name="Straight Connector 176">
                  <a:extLst>
                    <a:ext uri="{FF2B5EF4-FFF2-40B4-BE49-F238E27FC236}">
                      <a16:creationId xmlns:a16="http://schemas.microsoft.com/office/drawing/2014/main" id="{03BAE261-0D9F-BB4A-8543-10DDC5DC40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28349" y="4827999"/>
                  <a:ext cx="134829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8" name="Straight Connector 177">
                  <a:extLst>
                    <a:ext uri="{FF2B5EF4-FFF2-40B4-BE49-F238E27FC236}">
                      <a16:creationId xmlns:a16="http://schemas.microsoft.com/office/drawing/2014/main" id="{D47255B3-FDAB-9348-B69E-4011F2FF69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27449" y="2487685"/>
                  <a:ext cx="0" cy="2339813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9" name="Triangle 178">
                  <a:extLst>
                    <a:ext uri="{FF2B5EF4-FFF2-40B4-BE49-F238E27FC236}">
                      <a16:creationId xmlns:a16="http://schemas.microsoft.com/office/drawing/2014/main" id="{3B469139-5553-7843-8086-5B10945C4211}"/>
                    </a:ext>
                  </a:extLst>
                </p:cNvPr>
                <p:cNvSpPr/>
                <p:nvPr/>
              </p:nvSpPr>
              <p:spPr>
                <a:xfrm rot="5400000" flipV="1">
                  <a:off x="3602475" y="4781627"/>
                  <a:ext cx="15663" cy="92744"/>
                </a:xfrm>
                <a:prstGeom prst="triangle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0" name="Freeform 179">
                  <a:extLst>
                    <a:ext uri="{FF2B5EF4-FFF2-40B4-BE49-F238E27FC236}">
                      <a16:creationId xmlns:a16="http://schemas.microsoft.com/office/drawing/2014/main" id="{C9A02F1D-6469-654F-A2BE-C37960E97F8D}"/>
                    </a:ext>
                  </a:extLst>
                </p:cNvPr>
                <p:cNvSpPr/>
                <p:nvPr/>
              </p:nvSpPr>
              <p:spPr>
                <a:xfrm>
                  <a:off x="3886556" y="3166375"/>
                  <a:ext cx="186686" cy="1640322"/>
                </a:xfrm>
                <a:custGeom>
                  <a:avLst/>
                  <a:gdLst>
                    <a:gd name="connsiteX0" fmla="*/ 782515 w 782515"/>
                    <a:gd name="connsiteY0" fmla="*/ 6875585 h 6875585"/>
                    <a:gd name="connsiteX1" fmla="*/ 782515 w 782515"/>
                    <a:gd name="connsiteY1" fmla="*/ 0 h 6875585"/>
                    <a:gd name="connsiteX2" fmla="*/ 0 w 782515"/>
                    <a:gd name="connsiteY2" fmla="*/ 1011115 h 6875585"/>
                    <a:gd name="connsiteX3" fmla="*/ 782515 w 782515"/>
                    <a:gd name="connsiteY3" fmla="*/ 6875585 h 687558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2515" h="6875585">
                      <a:moveTo>
                        <a:pt x="782515" y="6875585"/>
                      </a:moveTo>
                      <a:lnTo>
                        <a:pt x="782515" y="0"/>
                      </a:lnTo>
                      <a:lnTo>
                        <a:pt x="0" y="1011115"/>
                      </a:lnTo>
                      <a:lnTo>
                        <a:pt x="782515" y="6875585"/>
                      </a:lnTo>
                      <a:close/>
                    </a:path>
                  </a:pathLst>
                </a:custGeom>
                <a:solidFill>
                  <a:schemeClr val="accent5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48" name="Freeform 247">
                  <a:extLst>
                    <a:ext uri="{FF2B5EF4-FFF2-40B4-BE49-F238E27FC236}">
                      <a16:creationId xmlns:a16="http://schemas.microsoft.com/office/drawing/2014/main" id="{666EC9FE-5AF4-114D-AE30-05305B31386A}"/>
                    </a:ext>
                  </a:extLst>
                </p:cNvPr>
                <p:cNvSpPr/>
                <p:nvPr/>
              </p:nvSpPr>
              <p:spPr>
                <a:xfrm>
                  <a:off x="3889007" y="2922036"/>
                  <a:ext cx="102595" cy="230030"/>
                </a:xfrm>
                <a:custGeom>
                  <a:avLst/>
                  <a:gdLst>
                    <a:gd name="connsiteX0" fmla="*/ 430040 w 430040"/>
                    <a:gd name="connsiteY0" fmla="*/ 0 h 964194"/>
                    <a:gd name="connsiteX1" fmla="*/ 430040 w 430040"/>
                    <a:gd name="connsiteY1" fmla="*/ 964194 h 964194"/>
                    <a:gd name="connsiteX2" fmla="*/ 0 w 430040"/>
                    <a:gd name="connsiteY2" fmla="*/ 497940 h 964194"/>
                    <a:gd name="connsiteX3" fmla="*/ 430040 w 430040"/>
                    <a:gd name="connsiteY3" fmla="*/ 0 h 96419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30040" h="964194">
                      <a:moveTo>
                        <a:pt x="430040" y="0"/>
                      </a:moveTo>
                      <a:lnTo>
                        <a:pt x="430040" y="964194"/>
                      </a:lnTo>
                      <a:lnTo>
                        <a:pt x="0" y="497940"/>
                      </a:lnTo>
                      <a:lnTo>
                        <a:pt x="430040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49" name="Freeform 248">
                  <a:extLst>
                    <a:ext uri="{FF2B5EF4-FFF2-40B4-BE49-F238E27FC236}">
                      <a16:creationId xmlns:a16="http://schemas.microsoft.com/office/drawing/2014/main" id="{87F10B58-96F1-3B41-91E4-F6B14A37280A}"/>
                    </a:ext>
                  </a:extLst>
                </p:cNvPr>
                <p:cNvSpPr/>
                <p:nvPr/>
              </p:nvSpPr>
              <p:spPr>
                <a:xfrm>
                  <a:off x="3850129" y="2779482"/>
                  <a:ext cx="112315" cy="130674"/>
                </a:xfrm>
                <a:custGeom>
                  <a:avLst/>
                  <a:gdLst>
                    <a:gd name="connsiteX0" fmla="*/ 470780 w 470780"/>
                    <a:gd name="connsiteY0" fmla="*/ 0 h 547735"/>
                    <a:gd name="connsiteX1" fmla="*/ 470780 w 470780"/>
                    <a:gd name="connsiteY1" fmla="*/ 547735 h 547735"/>
                    <a:gd name="connsiteX2" fmla="*/ 0 w 470780"/>
                    <a:gd name="connsiteY2" fmla="*/ 153909 h 547735"/>
                    <a:gd name="connsiteX3" fmla="*/ 470780 w 470780"/>
                    <a:gd name="connsiteY3" fmla="*/ 0 h 54773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70780" h="547735">
                      <a:moveTo>
                        <a:pt x="470780" y="0"/>
                      </a:moveTo>
                      <a:lnTo>
                        <a:pt x="470780" y="547735"/>
                      </a:lnTo>
                      <a:lnTo>
                        <a:pt x="0" y="153909"/>
                      </a:lnTo>
                      <a:lnTo>
                        <a:pt x="470780" y="0"/>
                      </a:lnTo>
                      <a:close/>
                    </a:path>
                  </a:pathLst>
                </a:custGeom>
                <a:solidFill>
                  <a:schemeClr val="bg1">
                    <a:lumMod val="9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53" name="Freeform 252">
                  <a:extLst>
                    <a:ext uri="{FF2B5EF4-FFF2-40B4-BE49-F238E27FC236}">
                      <a16:creationId xmlns:a16="http://schemas.microsoft.com/office/drawing/2014/main" id="{901E24C0-DE54-2849-A2EE-AD92DE13EFB5}"/>
                    </a:ext>
                  </a:extLst>
                </p:cNvPr>
                <p:cNvSpPr/>
                <p:nvPr/>
              </p:nvSpPr>
              <p:spPr>
                <a:xfrm>
                  <a:off x="3806931" y="2621809"/>
                  <a:ext cx="110155" cy="144713"/>
                </a:xfrm>
                <a:custGeom>
                  <a:avLst/>
                  <a:gdLst>
                    <a:gd name="connsiteX0" fmla="*/ 461727 w 461727"/>
                    <a:gd name="connsiteY0" fmla="*/ 0 h 606582"/>
                    <a:gd name="connsiteX1" fmla="*/ 461727 w 461727"/>
                    <a:gd name="connsiteY1" fmla="*/ 606582 h 606582"/>
                    <a:gd name="connsiteX2" fmla="*/ 0 w 461727"/>
                    <a:gd name="connsiteY2" fmla="*/ 253497 h 606582"/>
                    <a:gd name="connsiteX3" fmla="*/ 461727 w 461727"/>
                    <a:gd name="connsiteY3" fmla="*/ 0 h 60658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61727" h="606582">
                      <a:moveTo>
                        <a:pt x="461727" y="0"/>
                      </a:moveTo>
                      <a:lnTo>
                        <a:pt x="461727" y="606582"/>
                      </a:lnTo>
                      <a:lnTo>
                        <a:pt x="0" y="253497"/>
                      </a:lnTo>
                      <a:lnTo>
                        <a:pt x="461727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54" name="Freeform 253">
                  <a:extLst>
                    <a:ext uri="{FF2B5EF4-FFF2-40B4-BE49-F238E27FC236}">
                      <a16:creationId xmlns:a16="http://schemas.microsoft.com/office/drawing/2014/main" id="{B93732FE-4F1E-214D-BFDC-B8757E861F7A}"/>
                    </a:ext>
                  </a:extLst>
                </p:cNvPr>
                <p:cNvSpPr/>
                <p:nvPr/>
              </p:nvSpPr>
              <p:spPr>
                <a:xfrm>
                  <a:off x="3759413" y="2418843"/>
                  <a:ext cx="153353" cy="187911"/>
                </a:xfrm>
                <a:custGeom>
                  <a:avLst/>
                  <a:gdLst>
                    <a:gd name="connsiteX0" fmla="*/ 642796 w 642796"/>
                    <a:gd name="connsiteY0" fmla="*/ 0 h 787651"/>
                    <a:gd name="connsiteX1" fmla="*/ 642796 w 642796"/>
                    <a:gd name="connsiteY1" fmla="*/ 787651 h 787651"/>
                    <a:gd name="connsiteX2" fmla="*/ 0 w 642796"/>
                    <a:gd name="connsiteY2" fmla="*/ 149382 h 787651"/>
                    <a:gd name="connsiteX3" fmla="*/ 642796 w 642796"/>
                    <a:gd name="connsiteY3" fmla="*/ 0 h 7876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42796" h="787651">
                      <a:moveTo>
                        <a:pt x="642796" y="0"/>
                      </a:moveTo>
                      <a:lnTo>
                        <a:pt x="642796" y="787651"/>
                      </a:lnTo>
                      <a:lnTo>
                        <a:pt x="0" y="149382"/>
                      </a:lnTo>
                      <a:lnTo>
                        <a:pt x="642796" y="0"/>
                      </a:lnTo>
                      <a:close/>
                    </a:path>
                  </a:pathLst>
                </a:custGeom>
                <a:solidFill>
                  <a:schemeClr val="accent6"/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56" name="Freeform 255">
                  <a:extLst>
                    <a:ext uri="{FF2B5EF4-FFF2-40B4-BE49-F238E27FC236}">
                      <a16:creationId xmlns:a16="http://schemas.microsoft.com/office/drawing/2014/main" id="{7E4E5AC2-97A2-A540-BDAF-791561836E34}"/>
                    </a:ext>
                  </a:extLst>
                </p:cNvPr>
                <p:cNvSpPr/>
                <p:nvPr/>
              </p:nvSpPr>
              <p:spPr>
                <a:xfrm>
                  <a:off x="3663362" y="2132656"/>
                  <a:ext cx="166312" cy="273228"/>
                </a:xfrm>
                <a:custGeom>
                  <a:avLst/>
                  <a:gdLst>
                    <a:gd name="connsiteX0" fmla="*/ 697117 w 697117"/>
                    <a:gd name="connsiteY0" fmla="*/ 0 h 1145264"/>
                    <a:gd name="connsiteX1" fmla="*/ 697117 w 697117"/>
                    <a:gd name="connsiteY1" fmla="*/ 1145264 h 1145264"/>
                    <a:gd name="connsiteX2" fmla="*/ 0 w 697117"/>
                    <a:gd name="connsiteY2" fmla="*/ 787652 h 1145264"/>
                    <a:gd name="connsiteX3" fmla="*/ 697117 w 697117"/>
                    <a:gd name="connsiteY3" fmla="*/ 0 h 114526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97117" h="1145264">
                      <a:moveTo>
                        <a:pt x="697117" y="0"/>
                      </a:moveTo>
                      <a:lnTo>
                        <a:pt x="697117" y="1145264"/>
                      </a:lnTo>
                      <a:lnTo>
                        <a:pt x="0" y="787652"/>
                      </a:lnTo>
                      <a:lnTo>
                        <a:pt x="697117" y="0"/>
                      </a:lnTo>
                      <a:close/>
                    </a:path>
                  </a:pathLst>
                </a:cu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257" name="Straight Connector 256">
                  <a:extLst>
                    <a:ext uri="{FF2B5EF4-FFF2-40B4-BE49-F238E27FC236}">
                      <a16:creationId xmlns:a16="http://schemas.microsoft.com/office/drawing/2014/main" id="{407BB9F3-06D7-9C4E-98D0-2071B526C9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5604" y="2457886"/>
                  <a:ext cx="94627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Straight Connector 258">
                  <a:extLst>
                    <a:ext uri="{FF2B5EF4-FFF2-40B4-BE49-F238E27FC236}">
                      <a16:creationId xmlns:a16="http://schemas.microsoft.com/office/drawing/2014/main" id="{75180084-FBC9-794C-9623-90200E6E9F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64025" y="2322455"/>
                  <a:ext cx="0" cy="33129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Straight Connector 260">
                  <a:extLst>
                    <a:ext uri="{FF2B5EF4-FFF2-40B4-BE49-F238E27FC236}">
                      <a16:creationId xmlns:a16="http://schemas.microsoft.com/office/drawing/2014/main" id="{16C4CAC2-3715-844C-9A81-54CC098BC6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63674" y="2322455"/>
                  <a:ext cx="103994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Straight Connector 262">
                  <a:extLst>
                    <a:ext uri="{FF2B5EF4-FFF2-40B4-BE49-F238E27FC236}">
                      <a16:creationId xmlns:a16="http://schemas.microsoft.com/office/drawing/2014/main" id="{5F2EF443-E294-4B48-8284-967ACE96BC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63833" y="2653745"/>
                  <a:ext cx="101771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Straight Connector 264">
                  <a:extLst>
                    <a:ext uri="{FF2B5EF4-FFF2-40B4-BE49-F238E27FC236}">
                      <a16:creationId xmlns:a16="http://schemas.microsoft.com/office/drawing/2014/main" id="{D2C7E685-FD24-6248-951B-7CC36203E99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27449" y="2488529"/>
                  <a:ext cx="135748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Straight Connector 266">
                  <a:extLst>
                    <a:ext uri="{FF2B5EF4-FFF2-40B4-BE49-F238E27FC236}">
                      <a16:creationId xmlns:a16="http://schemas.microsoft.com/office/drawing/2014/main" id="{D8BD15D4-D39B-384B-AC80-395FB5C8BF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5763" y="2849572"/>
                  <a:ext cx="94627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Straight Connector 268">
                  <a:extLst>
                    <a:ext uri="{FF2B5EF4-FFF2-40B4-BE49-F238E27FC236}">
                      <a16:creationId xmlns:a16="http://schemas.microsoft.com/office/drawing/2014/main" id="{CAC3DFF0-3136-1142-A463-0E6D06F955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8336" y="2457886"/>
                  <a:ext cx="0" cy="39210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1" name="Straight Connector 270">
                  <a:extLst>
                    <a:ext uri="{FF2B5EF4-FFF2-40B4-BE49-F238E27FC236}">
                      <a16:creationId xmlns:a16="http://schemas.microsoft.com/office/drawing/2014/main" id="{390578A7-AFC1-1E44-9F07-39D7A92C6F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59119" y="2682070"/>
                  <a:ext cx="48266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6" name="Straight Connector 275">
                  <a:extLst>
                    <a:ext uri="{FF2B5EF4-FFF2-40B4-BE49-F238E27FC236}">
                      <a16:creationId xmlns:a16="http://schemas.microsoft.com/office/drawing/2014/main" id="{D2ABA3FA-6F3D-EB4E-A15A-EF94248615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59119" y="3019456"/>
                  <a:ext cx="48266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Straight Connector 276">
                  <a:extLst>
                    <a:ext uri="{FF2B5EF4-FFF2-40B4-BE49-F238E27FC236}">
                      <a16:creationId xmlns:a16="http://schemas.microsoft.com/office/drawing/2014/main" id="{CE89A911-8BFD-234E-9657-1AC1EBBC00B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59119" y="2680958"/>
                  <a:ext cx="0" cy="338594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8" name="Straight Connector 277">
                  <a:extLst>
                    <a:ext uri="{FF2B5EF4-FFF2-40B4-BE49-F238E27FC236}">
                      <a16:creationId xmlns:a16="http://schemas.microsoft.com/office/drawing/2014/main" id="{205C5BF4-266D-D541-BB84-F3F9B34BDC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7544" y="2816548"/>
                  <a:ext cx="43821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Straight Connector 278">
                  <a:extLst>
                    <a:ext uri="{FF2B5EF4-FFF2-40B4-BE49-F238E27FC236}">
                      <a16:creationId xmlns:a16="http://schemas.microsoft.com/office/drawing/2014/main" id="{643F574B-9CE9-6F4F-9B10-2C9BFFE079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6750" y="3223476"/>
                  <a:ext cx="43821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0" name="Straight Connector 279">
                  <a:extLst>
                    <a:ext uri="{FF2B5EF4-FFF2-40B4-BE49-F238E27FC236}">
                      <a16:creationId xmlns:a16="http://schemas.microsoft.com/office/drawing/2014/main" id="{229914FD-F4A5-7641-B0FA-1FA59AEFF3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7861" y="2815437"/>
                  <a:ext cx="0" cy="408929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3" name="Straight Connector 282">
                  <a:extLst>
                    <a:ext uri="{FF2B5EF4-FFF2-40B4-BE49-F238E27FC236}">
                      <a16:creationId xmlns:a16="http://schemas.microsoft.com/office/drawing/2014/main" id="{A3CB1B25-7209-6043-A5C0-E0C547F2D0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50729" y="3040731"/>
                  <a:ext cx="36835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5" name="Straight Connector 284">
                  <a:extLst>
                    <a:ext uri="{FF2B5EF4-FFF2-40B4-BE49-F238E27FC236}">
                      <a16:creationId xmlns:a16="http://schemas.microsoft.com/office/drawing/2014/main" id="{8A4D5485-9317-094B-87C4-DA5B0DA5A5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49935" y="3406696"/>
                  <a:ext cx="36835" cy="0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6" name="Straight Connector 285">
                  <a:extLst>
                    <a:ext uri="{FF2B5EF4-FFF2-40B4-BE49-F238E27FC236}">
                      <a16:creationId xmlns:a16="http://schemas.microsoft.com/office/drawing/2014/main" id="{D55FAE8C-A465-7A48-9806-B2E8A63127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50888" y="3039461"/>
                  <a:ext cx="0" cy="367808"/>
                </a:xfrm>
                <a:prstGeom prst="line">
                  <a:avLst/>
                </a:prstGeom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613F8163-E5FE-8642-A6E9-3EA8B3A6DEB9}"/>
                    </a:ext>
                  </a:extLst>
                </p:cNvPr>
                <p:cNvSpPr txBox="1"/>
                <p:nvPr/>
              </p:nvSpPr>
              <p:spPr>
                <a:xfrm>
                  <a:off x="3880486" y="2428468"/>
                  <a:ext cx="816249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solidFill>
                        <a:schemeClr val="accent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lade 2 </a:t>
                  </a:r>
                  <a:r>
                    <a:rPr lang="en-GB" sz="500" dirty="0" err="1">
                      <a:solidFill>
                        <a:schemeClr val="accent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csA</a:t>
                  </a:r>
                  <a:r>
                    <a:rPr lang="en-GB" sz="500" dirty="0">
                      <a:solidFill>
                        <a:schemeClr val="accent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proteins</a:t>
                  </a:r>
                </a:p>
              </p:txBody>
            </p:sp>
            <p:sp>
              <p:nvSpPr>
                <p:cNvPr id="288" name="TextBox 287">
                  <a:extLst>
                    <a:ext uri="{FF2B5EF4-FFF2-40B4-BE49-F238E27FC236}">
                      <a16:creationId xmlns:a16="http://schemas.microsoft.com/office/drawing/2014/main" id="{9136F2AD-FD72-5540-B8E7-D734CF2463A3}"/>
                    </a:ext>
                  </a:extLst>
                </p:cNvPr>
                <p:cNvSpPr txBox="1"/>
                <p:nvPr/>
              </p:nvSpPr>
              <p:spPr>
                <a:xfrm>
                  <a:off x="3798108" y="2190515"/>
                  <a:ext cx="40427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de 1</a:t>
                  </a:r>
                </a:p>
              </p:txBody>
            </p: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4B41EDE3-8206-1E48-9E20-D3BD638E3155}"/>
                    </a:ext>
                  </a:extLst>
                </p:cNvPr>
                <p:cNvSpPr txBox="1"/>
                <p:nvPr/>
              </p:nvSpPr>
              <p:spPr>
                <a:xfrm>
                  <a:off x="3884604" y="2610644"/>
                  <a:ext cx="40427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de 3</a:t>
                  </a:r>
                </a:p>
              </p:txBody>
            </p: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1880BF19-1AF9-2D48-82D4-8AB448D2819D}"/>
                    </a:ext>
                  </a:extLst>
                </p:cNvPr>
                <p:cNvSpPr txBox="1"/>
                <p:nvPr/>
              </p:nvSpPr>
              <p:spPr>
                <a:xfrm>
                  <a:off x="3934032" y="2758925"/>
                  <a:ext cx="40427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de 4</a:t>
                  </a:r>
                </a:p>
              </p:txBody>
            </p:sp>
            <p:sp>
              <p:nvSpPr>
                <p:cNvPr id="291" name="TextBox 290">
                  <a:extLst>
                    <a:ext uri="{FF2B5EF4-FFF2-40B4-BE49-F238E27FC236}">
                      <a16:creationId xmlns:a16="http://schemas.microsoft.com/office/drawing/2014/main" id="{EDA03CF6-4C54-9143-9EA2-6C1BADDB4F24}"/>
                    </a:ext>
                  </a:extLst>
                </p:cNvPr>
                <p:cNvSpPr txBox="1"/>
                <p:nvPr/>
              </p:nvSpPr>
              <p:spPr>
                <a:xfrm>
                  <a:off x="3958745" y="2952514"/>
                  <a:ext cx="40427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de 5</a:t>
                  </a:r>
                </a:p>
              </p:txBody>
            </p:sp>
            <p:sp>
              <p:nvSpPr>
                <p:cNvPr id="292" name="TextBox 291">
                  <a:extLst>
                    <a:ext uri="{FF2B5EF4-FFF2-40B4-BE49-F238E27FC236}">
                      <a16:creationId xmlns:a16="http://schemas.microsoft.com/office/drawing/2014/main" id="{0C4DEC3F-0511-7944-A163-A4A5C267BDDE}"/>
                    </a:ext>
                  </a:extLst>
                </p:cNvPr>
                <p:cNvSpPr txBox="1"/>
                <p:nvPr/>
              </p:nvSpPr>
              <p:spPr>
                <a:xfrm>
                  <a:off x="4045243" y="3838082"/>
                  <a:ext cx="665567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solidFill>
                        <a:schemeClr val="accent5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lade 6 Orphans</a:t>
                  </a:r>
                </a:p>
              </p:txBody>
            </p: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250580A0-1A88-D64D-B575-25836FB733BE}"/>
                    </a:ext>
                  </a:extLst>
                </p:cNvPr>
                <p:cNvSpPr txBox="1"/>
                <p:nvPr/>
              </p:nvSpPr>
              <p:spPr>
                <a:xfrm>
                  <a:off x="3625112" y="4746474"/>
                  <a:ext cx="40427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ade 7</a:t>
                  </a:r>
                </a:p>
              </p:txBody>
            </p:sp>
          </p:grp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3D6CEB44-E9C1-F84B-BC6A-C7CAA494509B}"/>
                  </a:ext>
                </a:extLst>
              </p:cNvPr>
              <p:cNvSpPr txBox="1"/>
              <p:nvPr/>
            </p:nvSpPr>
            <p:spPr>
              <a:xfrm>
                <a:off x="3308944" y="1792447"/>
                <a:ext cx="13098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A) All homologs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F5DB58A-0D29-B8DA-C7E7-A4CAAD8AD013}"/>
              </a:ext>
            </a:extLst>
          </p:cNvPr>
          <p:cNvSpPr txBox="1"/>
          <p:nvPr/>
        </p:nvSpPr>
        <p:spPr>
          <a:xfrm rot="20424078">
            <a:off x="1485554" y="5109500"/>
            <a:ext cx="7476856" cy="355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>
                    <a:lumMod val="75000"/>
                  </a:schemeClr>
                </a:solidFill>
              </a:rPr>
              <a:t>DRAFT FIGURE – DRAFT FIGURE – DRAFT FIGURE – DRAFT FIGURE – DRAFT FIGURE </a:t>
            </a:r>
          </a:p>
        </p:txBody>
      </p:sp>
    </p:spTree>
    <p:extLst>
      <p:ext uri="{BB962C8B-B14F-4D97-AF65-F5344CB8AC3E}">
        <p14:creationId xmlns:p14="http://schemas.microsoft.com/office/powerpoint/2010/main" val="722106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9</TotalTime>
  <Words>94</Words>
  <Application>Microsoft Macintosh PowerPoint</Application>
  <PresentationFormat>A3 Paper (297x420 mm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10</cp:revision>
  <dcterms:created xsi:type="dcterms:W3CDTF">2021-12-08T10:28:46Z</dcterms:created>
  <dcterms:modified xsi:type="dcterms:W3CDTF">2022-08-24T16:52:20Z</dcterms:modified>
</cp:coreProperties>
</file>